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313" r:id="rId2"/>
    <p:sldId id="337" r:id="rId3"/>
    <p:sldId id="338" r:id="rId4"/>
    <p:sldId id="339" r:id="rId5"/>
    <p:sldId id="340" r:id="rId6"/>
    <p:sldId id="341" r:id="rId7"/>
    <p:sldId id="342" r:id="rId8"/>
    <p:sldId id="334" r:id="rId9"/>
    <p:sldId id="304" r:id="rId10"/>
    <p:sldId id="306" r:id="rId11"/>
    <p:sldId id="302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9688" autoAdjust="0"/>
  </p:normalViewPr>
  <p:slideViewPr>
    <p:cSldViewPr snapToGrid="0">
      <p:cViewPr varScale="1">
        <p:scale>
          <a:sx n="88" d="100"/>
          <a:sy n="88" d="100"/>
        </p:scale>
        <p:origin x="696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D427F-0663-4BDC-9B9D-2984E87DDCFA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B3B0F8-A4EC-4CF4-ADC0-0C2877A22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3870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1: </a:t>
            </a:r>
            <a:r>
              <a:rPr lang="en-US" b="0" dirty="0"/>
              <a:t>General characterization of CTRL and SCZ co-expression network modules. Left panels and upper right panel: cluster dendrograms with SCZ modules and CTRL modules matched by color; lower right panel: table with WGCNA results for the region x diagnosis co-expression network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B3B0F8-A4EC-4CF4-ADC0-0C2877A2297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81797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10 figure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Correlations between case-control absolute difference for total connectivity (degree) (K) across DLPFC, hippocampus and caudate (method Kendall’s tau)</a:t>
            </a:r>
            <a:endParaRPr lang="en-US" sz="1800" kern="100" dirty="0">
              <a:effectLst/>
              <a:latin typeface="Calibri" panose="020F0502020204030204" pitchFamily="34" charset="0"/>
              <a:ea typeface="Aptos" panose="020B00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B3B0F8-A4EC-4CF4-ADC0-0C2877A22976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41843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11 figure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Correlations between case-control absolute difference for clustering coefficient (C) across DLPFC, hippocampus and caudate (method Kendall’s tau)</a:t>
            </a:r>
            <a:endParaRPr lang="en-US" sz="1800" kern="100" dirty="0">
              <a:effectLst/>
              <a:latin typeface="Calibri" panose="020F0502020204030204" pitchFamily="34" charset="0"/>
              <a:ea typeface="Aptos" panose="020B00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B3B0F8-A4EC-4CF4-ADC0-0C2877A22976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5355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2 figure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ummary of GO:BP for control DLPFC modules (scatter plot visualization of biological ontologies with package </a:t>
            </a:r>
            <a:r>
              <a:rPr lang="en-US" sz="1800" i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rrvgo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(v.1.18.0) in R)</a:t>
            </a:r>
            <a:endParaRPr lang="en-US" sz="1800" kern="100" dirty="0">
              <a:effectLst/>
              <a:latin typeface="Calibri" panose="020F0502020204030204" pitchFamily="34" charset="0"/>
              <a:ea typeface="Aptos" panose="020B00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B3B0F8-A4EC-4CF4-ADC0-0C2877A2297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58481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3 figure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ummary of GO:BP for schizophrenia DLPFC modules (scatter plot visualization of biological ontologies with package </a:t>
            </a:r>
            <a:r>
              <a:rPr lang="en-US" sz="1800" i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rrvgo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(v.1.18.0) in R)</a:t>
            </a:r>
            <a:endParaRPr lang="en-US" sz="1800" kern="100" dirty="0">
              <a:effectLst/>
              <a:latin typeface="Calibri" panose="020F0502020204030204" pitchFamily="34" charset="0"/>
              <a:ea typeface="Aptos" panose="020B00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B3B0F8-A4EC-4CF4-ADC0-0C2877A2297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6787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4 figure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ummary of GO:BP for control hippocampus modules (scatter plot visualization of biological ontologies with package </a:t>
            </a:r>
            <a:r>
              <a:rPr lang="en-US" sz="1800" i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rrvgo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(v.1.18.0) in R)</a:t>
            </a:r>
            <a:endParaRPr lang="en-US" sz="1800" kern="100" dirty="0">
              <a:effectLst/>
              <a:latin typeface="Calibri" panose="020F0502020204030204" pitchFamily="34" charset="0"/>
              <a:ea typeface="Aptos" panose="020B00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B3B0F8-A4EC-4CF4-ADC0-0C2877A2297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78679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5 figure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ummary of GO:BP for schizophrenia hippocampus modules (scatter plot visualization of biological ontologies with package </a:t>
            </a:r>
            <a:r>
              <a:rPr lang="en-US" sz="1800" i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rrvgo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(v.1.18.0) in R)</a:t>
            </a:r>
            <a:endParaRPr lang="en-US" sz="1800" kern="100" dirty="0">
              <a:effectLst/>
              <a:latin typeface="Calibri" panose="020F0502020204030204" pitchFamily="34" charset="0"/>
              <a:ea typeface="Aptos" panose="020B00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B3B0F8-A4EC-4CF4-ADC0-0C2877A2297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66569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6 figure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ummary of GO:BP for control caudate modules (scatter plot visualization of biological ontologies with package </a:t>
            </a:r>
            <a:r>
              <a:rPr lang="en-US" sz="1800" i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rrvgo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(v.1.18.0) in R)</a:t>
            </a:r>
            <a:endParaRPr lang="en-US" sz="1800" kern="100" dirty="0">
              <a:effectLst/>
              <a:latin typeface="Calibri" panose="020F0502020204030204" pitchFamily="34" charset="0"/>
              <a:ea typeface="Aptos" panose="020B00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B3B0F8-A4EC-4CF4-ADC0-0C2877A2297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11799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7 figure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ummary of GO:BP for schizophrenia Caudate modules (scatter plot visualization of biological ontologies with package </a:t>
            </a:r>
            <a:r>
              <a:rPr lang="en-US" sz="1800" i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rrvgo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(v.1.18.0) in R)</a:t>
            </a:r>
            <a:endParaRPr lang="en-US" sz="1800" kern="100" dirty="0">
              <a:effectLst/>
              <a:latin typeface="Calibri" panose="020F0502020204030204" pitchFamily="34" charset="0"/>
              <a:ea typeface="Aptos" panose="020B00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B3B0F8-A4EC-4CF4-ADC0-0C2877A22976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59588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8: </a:t>
            </a:r>
            <a:r>
              <a:rPr lang="en-US" dirty="0"/>
              <a:t>Module preservation of CTRL modules in SCZ gene co-expression networks (Hippo=hippocampus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B3B0F8-A4EC-4CF4-ADC0-0C2877A2297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82538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9 figure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Correlations between case-control absolute difference for intra-module degree (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kIn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) across DLPFC, hippocampus and caudate (method Kendall’s tau)</a:t>
            </a:r>
            <a:endParaRPr lang="en-US" sz="1800" kern="100" dirty="0">
              <a:effectLst/>
              <a:latin typeface="Calibri" panose="020F0502020204030204" pitchFamily="34" charset="0"/>
              <a:ea typeface="Aptos" panose="020B00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B3B0F8-A4EC-4CF4-ADC0-0C2877A22976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3398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5F4788-9BAC-B28D-932C-AA367EAFEB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6699AE7-8635-1B5E-94EC-200BCBE92E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E130C4-6D90-3702-0F74-811479A461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5D230C-1972-635D-F73E-C8F9D2C6E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6F0E48-AFFC-4221-68B6-182ECE8417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419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F217E1-E00C-5D3E-4C0E-D3713884A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DE9624-72FA-F84C-4DAA-09A8D68025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459D95-CB87-7538-E7FB-3BF872E7A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F0BB03-D9A4-4154-22DC-1FBA6846E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5B437B-89DB-6B5F-7333-32AB6F52B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446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F60663-DC34-9109-7B3E-DB4B5642B2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EDF61C-5039-A734-57A8-E9ECD91DBD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CBBF35-CE4E-D779-BED2-7BA65DC0D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7E4C9B-92A5-784F-C4A3-60531621D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9D841F-44E2-5625-20C1-68F0E9B0A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2498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FFCAFA-28E9-B6AA-4F1E-8406BF410C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005FDB-2802-D42F-3CB7-AA6FE353B8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FD1527-15B6-51C9-AB47-2B4D545E87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CC3313-8E1F-B9C3-E94E-9FE6E6B42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CF9B32-9380-875C-67E9-92087782DF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223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5B49E2-3EA0-CC21-BB4E-43047A0EF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F60F4D-9E3B-0512-89AE-939CBFE1E8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ED1F31-1B19-C8FB-4C03-8CC555D35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FD6A07-3E6D-4C94-E920-A3A07B2EF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3A21D1-E3EE-EAFF-A3F8-B677F7746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349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8E9C21-57FC-1B0C-1A2C-FE383D8E10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412672-B2C4-95CA-B2D6-F64F587155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632D06-F44C-DF6D-5877-BEFCECDAC1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AB418C-2680-FB12-E6EC-3DCDB555F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8FF7D7-17E7-EB93-69A9-142F963F8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45755F-CC10-171F-75E1-1336FA8DD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724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F75ADE-FD55-6F92-A05E-3AAA63E978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E38AC3-E1AF-A531-3E45-CEC882A49C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0856BA-4523-C8A0-DB46-9D0610AF18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BC88C9-F781-2D33-9AD7-80DC398F73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DB1B1B-9010-CC85-F08F-8F02F65A6D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0F2E7C6-8C8D-5D51-CEDA-5FF208FF4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98C4E57-A7C4-54B6-739E-73BA671F7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5444476-C5B6-243B-F1F5-6BDB47146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682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BD183E-77D4-3780-B789-F2151E7F0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B76B58-4C2B-90E2-7947-BB5E20CAB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FC22CD-4A36-9445-FC49-0E1FCFB38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15F60C0-FE4D-F2D1-E330-15A2F6B8C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827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1FCB4C-91F4-F306-2CBF-9EF0F8B61E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C31FC8F-951F-FD52-EB6B-11887535B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69618F-E07B-2235-E50E-441950F4B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935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E09AD6-0BF2-FC5B-08BF-7EDBD0FEF5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97C27B-744A-DB16-CBD2-11BAD279C6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BDFF1F-5F97-7791-9D92-516D0A842B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42B993-5BE0-AF3F-964A-F5D7EF100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B38B2B-E3AF-8069-33A8-9D000F8EF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987ED9-2999-D8BA-F236-7FBED6F7A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501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6B0FBB-F122-F4D2-9CD2-7511F96BE9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148452-E2D8-99A4-536E-2597B9BBDE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57566B-164A-C6D3-A465-59A628595B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E1B3EA-4728-FED3-9FC0-ABB58EF0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A17F91-58A5-246C-DA05-A76C73D79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9FCE3B-BB0A-A360-B345-6D55F3CEAF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201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F7FF4A-4988-727A-CC91-698F2CF1E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09D910-1D10-940F-B981-6B2324F2B1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41CB38-D50E-2611-AE7A-320959E88C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021AFD-095A-48D1-9E80-835550AD14C1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6C60EE-3B09-32AB-1398-7E5977A6F0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9420B1-45D1-7482-F2BF-BBBCCB3837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90FD48-BBE6-4614-AE4E-19679EC01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2949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dna test&#10;&#10;Description automatically generated with medium confidence">
            <a:extLst>
              <a:ext uri="{FF2B5EF4-FFF2-40B4-BE49-F238E27FC236}">
                <a16:creationId xmlns:a16="http://schemas.microsoft.com/office/drawing/2014/main" id="{D2F958FC-E5A2-6541-F385-0CF5C0CCEE9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6" r="3381"/>
          <a:stretch/>
        </p:blipFill>
        <p:spPr>
          <a:xfrm>
            <a:off x="84498" y="316707"/>
            <a:ext cx="6011502" cy="3009112"/>
          </a:xfrm>
          <a:prstGeom prst="rect">
            <a:avLst/>
          </a:prstGeom>
        </p:spPr>
      </p:pic>
      <p:pic>
        <p:nvPicPr>
          <p:cNvPr id="7" name="Picture 6" descr="A screen shot of a test&#10;&#10;Description automatically generated">
            <a:extLst>
              <a:ext uri="{FF2B5EF4-FFF2-40B4-BE49-F238E27FC236}">
                <a16:creationId xmlns:a16="http://schemas.microsoft.com/office/drawing/2014/main" id="{8B1C1C2E-A7DE-ADE0-3567-CD847309A13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1" r="4033"/>
          <a:stretch/>
        </p:blipFill>
        <p:spPr>
          <a:xfrm>
            <a:off x="6150409" y="316708"/>
            <a:ext cx="5963136" cy="3009111"/>
          </a:xfrm>
          <a:prstGeom prst="rect">
            <a:avLst/>
          </a:prstGeom>
        </p:spPr>
      </p:pic>
      <p:pic>
        <p:nvPicPr>
          <p:cNvPr id="9" name="Picture 8" descr="A close-up of a graph&#10;&#10;Description automatically generated">
            <a:extLst>
              <a:ext uri="{FF2B5EF4-FFF2-40B4-BE49-F238E27FC236}">
                <a16:creationId xmlns:a16="http://schemas.microsoft.com/office/drawing/2014/main" id="{1F82CE67-64D4-4EE9-1A72-F4BF3F8964E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2" r="2388"/>
          <a:stretch/>
        </p:blipFill>
        <p:spPr>
          <a:xfrm>
            <a:off x="84499" y="3562722"/>
            <a:ext cx="6011501" cy="2978569"/>
          </a:xfrm>
          <a:prstGeom prst="rect">
            <a:avLst/>
          </a:prstGeom>
        </p:spPr>
      </p:pic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8626BD53-38F0-7E59-47B0-AA1E7783A9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0243897"/>
              </p:ext>
            </p:extLst>
          </p:nvPr>
        </p:nvGraphicFramePr>
        <p:xfrm>
          <a:off x="6681457" y="4502441"/>
          <a:ext cx="5006251" cy="1487805"/>
        </p:xfrm>
        <a:graphic>
          <a:graphicData uri="http://schemas.openxmlformats.org/drawingml/2006/table">
            <a:tbl>
              <a:tblPr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tableStyleId>{D7AC3CCA-C797-4891-BE02-D94E43425B78}</a:tableStyleId>
              </a:tblPr>
              <a:tblGrid>
                <a:gridCol w="930105">
                  <a:extLst>
                    <a:ext uri="{9D8B030D-6E8A-4147-A177-3AD203B41FA5}">
                      <a16:colId xmlns:a16="http://schemas.microsoft.com/office/drawing/2014/main" val="573420533"/>
                    </a:ext>
                  </a:extLst>
                </a:gridCol>
                <a:gridCol w="626597">
                  <a:extLst>
                    <a:ext uri="{9D8B030D-6E8A-4147-A177-3AD203B41FA5}">
                      <a16:colId xmlns:a16="http://schemas.microsoft.com/office/drawing/2014/main" val="51274366"/>
                    </a:ext>
                  </a:extLst>
                </a:gridCol>
                <a:gridCol w="1282566">
                  <a:extLst>
                    <a:ext uri="{9D8B030D-6E8A-4147-A177-3AD203B41FA5}">
                      <a16:colId xmlns:a16="http://schemas.microsoft.com/office/drawing/2014/main" val="577034173"/>
                    </a:ext>
                  </a:extLst>
                </a:gridCol>
                <a:gridCol w="783247">
                  <a:extLst>
                    <a:ext uri="{9D8B030D-6E8A-4147-A177-3AD203B41FA5}">
                      <a16:colId xmlns:a16="http://schemas.microsoft.com/office/drawing/2014/main" val="2661780871"/>
                    </a:ext>
                  </a:extLst>
                </a:gridCol>
                <a:gridCol w="1383736">
                  <a:extLst>
                    <a:ext uri="{9D8B030D-6E8A-4147-A177-3AD203B41FA5}">
                      <a16:colId xmlns:a16="http://schemas.microsoft.com/office/drawing/2014/main" val="204418747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umber of module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Module siz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umber of grey gene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303556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DLPF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TR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3-30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4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939847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C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0-212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46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240571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Hippocampu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TR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55-9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46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4144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C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1-12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7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6103299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Caudat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TR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1-26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5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267310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C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0-19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207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9063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2432841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ollage of graphs and diagrams&#10;&#10;Description automatically generated">
            <a:extLst>
              <a:ext uri="{FF2B5EF4-FFF2-40B4-BE49-F238E27FC236}">
                <a16:creationId xmlns:a16="http://schemas.microsoft.com/office/drawing/2014/main" id="{A29E46DD-7A11-7BE9-B384-A3CCD2F0EE2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9377" y="758137"/>
            <a:ext cx="7621064" cy="57157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1260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graph&#10;&#10;Description automatically generated">
            <a:extLst>
              <a:ext uri="{FF2B5EF4-FFF2-40B4-BE49-F238E27FC236}">
                <a16:creationId xmlns:a16="http://schemas.microsoft.com/office/drawing/2014/main" id="{22BFE43C-6420-BB99-AAD3-DA22159975D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5468" y="571101"/>
            <a:ext cx="7621064" cy="57157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01183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olorful circles and text&#10;&#10;Description automatically generated with medium confidence">
            <a:extLst>
              <a:ext uri="{FF2B5EF4-FFF2-40B4-BE49-F238E27FC236}">
                <a16:creationId xmlns:a16="http://schemas.microsoft.com/office/drawing/2014/main" id="{1A4C568F-00FE-0E92-859B-2858B10D235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9" t="2384" r="880" b="3055"/>
          <a:stretch/>
        </p:blipFill>
        <p:spPr>
          <a:xfrm>
            <a:off x="238990" y="290946"/>
            <a:ext cx="11866419" cy="58604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03925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colorful dots&#10;&#10;Description automatically generated">
            <a:extLst>
              <a:ext uri="{FF2B5EF4-FFF2-40B4-BE49-F238E27FC236}">
                <a16:creationId xmlns:a16="http://schemas.microsoft.com/office/drawing/2014/main" id="{35FB46DE-4059-0318-3091-D9640C5B48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0" t="2050" r="2584" b="3390"/>
          <a:stretch/>
        </p:blipFill>
        <p:spPr>
          <a:xfrm>
            <a:off x="277090" y="498763"/>
            <a:ext cx="11637819" cy="58604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16958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colorful circles&#10;&#10;Description automatically generated">
            <a:extLst>
              <a:ext uri="{FF2B5EF4-FFF2-40B4-BE49-F238E27FC236}">
                <a16:creationId xmlns:a16="http://schemas.microsoft.com/office/drawing/2014/main" id="{BABEF434-1E6C-40A2-E9CA-500481B76A1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7" t="1881" r="1051" b="4900"/>
          <a:stretch/>
        </p:blipFill>
        <p:spPr>
          <a:xfrm>
            <a:off x="249380" y="446809"/>
            <a:ext cx="11710555" cy="57773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27414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olorful dots and lines&#10;&#10;Description automatically generated with medium confidence">
            <a:extLst>
              <a:ext uri="{FF2B5EF4-FFF2-40B4-BE49-F238E27FC236}">
                <a16:creationId xmlns:a16="http://schemas.microsoft.com/office/drawing/2014/main" id="{6B47B1EE-C5D3-D3EC-ADB9-0995684EDC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5" t="2217" r="881" b="4899"/>
          <a:stretch/>
        </p:blipFill>
        <p:spPr>
          <a:xfrm>
            <a:off x="228600" y="467590"/>
            <a:ext cx="11856027" cy="57565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86976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colorful dots&#10;&#10;Description automatically generated">
            <a:extLst>
              <a:ext uri="{FF2B5EF4-FFF2-40B4-BE49-F238E27FC236}">
                <a16:creationId xmlns:a16="http://schemas.microsoft.com/office/drawing/2014/main" id="{3C2C5E79-BA47-F23F-D13C-B1DB6A238B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0" t="2552" r="710" b="3391"/>
          <a:stretch/>
        </p:blipFill>
        <p:spPr>
          <a:xfrm>
            <a:off x="162790" y="550718"/>
            <a:ext cx="11866419" cy="58293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96215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colorful circles&#10;&#10;Description automatically generated">
            <a:extLst>
              <a:ext uri="{FF2B5EF4-FFF2-40B4-BE49-F238E27FC236}">
                <a16:creationId xmlns:a16="http://schemas.microsoft.com/office/drawing/2014/main" id="{67EBB5FE-84E7-17BC-94C1-B2C6CD2AA52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0200"/>
            <a:ext cx="12192000" cy="619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93103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different sizes of data&#10;&#10;Description automatically generated with medium confidence">
            <a:extLst>
              <a:ext uri="{FF2B5EF4-FFF2-40B4-BE49-F238E27FC236}">
                <a16:creationId xmlns:a16="http://schemas.microsoft.com/office/drawing/2014/main" id="{1DF8343E-B8C8-2F8F-013B-CB9BCE0ABA6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026"/>
          <a:stretch/>
        </p:blipFill>
        <p:spPr>
          <a:xfrm>
            <a:off x="172982" y="1638677"/>
            <a:ext cx="3760514" cy="3434895"/>
          </a:xfrm>
          <a:prstGeom prst="rect">
            <a:avLst/>
          </a:prstGeom>
        </p:spPr>
      </p:pic>
      <p:pic>
        <p:nvPicPr>
          <p:cNvPr id="5" name="Picture 4" descr="A comparison of a diagram&#10;&#10;Description automatically generated with medium confidence">
            <a:extLst>
              <a:ext uri="{FF2B5EF4-FFF2-40B4-BE49-F238E27FC236}">
                <a16:creationId xmlns:a16="http://schemas.microsoft.com/office/drawing/2014/main" id="{BCD377E5-A276-E278-11CD-97BD66A4028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356"/>
          <a:stretch/>
        </p:blipFill>
        <p:spPr>
          <a:xfrm>
            <a:off x="4434390" y="1638676"/>
            <a:ext cx="3299635" cy="3434895"/>
          </a:xfrm>
          <a:prstGeom prst="rect">
            <a:avLst/>
          </a:prstGeom>
        </p:spPr>
      </p:pic>
      <p:pic>
        <p:nvPicPr>
          <p:cNvPr id="7" name="Picture 6" descr="A diagram of different sizes of data&#10;&#10;Description automatically generated with medium confidence">
            <a:extLst>
              <a:ext uri="{FF2B5EF4-FFF2-40B4-BE49-F238E27FC236}">
                <a16:creationId xmlns:a16="http://schemas.microsoft.com/office/drawing/2014/main" id="{2A52DB1E-4F1C-37F9-C92D-3C92240D99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892"/>
          <a:stretch/>
        </p:blipFill>
        <p:spPr>
          <a:xfrm>
            <a:off x="8397873" y="1638676"/>
            <a:ext cx="3552701" cy="344077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9FE19A15-F9B6-9A2F-FE3A-8FADF646B039}"/>
              </a:ext>
            </a:extLst>
          </p:cNvPr>
          <p:cNvSpPr/>
          <p:nvPr/>
        </p:nvSpPr>
        <p:spPr>
          <a:xfrm>
            <a:off x="70501" y="1004935"/>
            <a:ext cx="3944477" cy="4581053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B7493F4-FD86-1538-FFDE-E7B925A38481}"/>
              </a:ext>
            </a:extLst>
          </p:cNvPr>
          <p:cNvSpPr/>
          <p:nvPr/>
        </p:nvSpPr>
        <p:spPr>
          <a:xfrm>
            <a:off x="4198624" y="1004934"/>
            <a:ext cx="3795530" cy="4581053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ABADC9A-FA32-E945-4CE7-AD8F375983AB}"/>
              </a:ext>
            </a:extLst>
          </p:cNvPr>
          <p:cNvSpPr/>
          <p:nvPr/>
        </p:nvSpPr>
        <p:spPr>
          <a:xfrm>
            <a:off x="8162107" y="1015335"/>
            <a:ext cx="3944477" cy="4581053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5286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graph&#10;&#10;Description automatically generated">
            <a:extLst>
              <a:ext uri="{FF2B5EF4-FFF2-40B4-BE49-F238E27FC236}">
                <a16:creationId xmlns:a16="http://schemas.microsoft.com/office/drawing/2014/main" id="{BA66747B-8A46-2CC1-BDEA-0B549E9E905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2113" y="571101"/>
            <a:ext cx="7621064" cy="57157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20768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09</TotalTime>
  <Words>371</Words>
  <Application>Microsoft Office PowerPoint</Application>
  <PresentationFormat>Widescreen</PresentationFormat>
  <Paragraphs>52</Paragraphs>
  <Slides>11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8" baseType="lpstr">
      <vt:lpstr>Aptos</vt:lpstr>
      <vt:lpstr>Aptos Display</vt:lpstr>
      <vt:lpstr>Aptos Narrow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ugenia Radulescu</dc:creator>
  <cp:lastModifiedBy>Eugenia Radulescu</cp:lastModifiedBy>
  <cp:revision>90</cp:revision>
  <dcterms:created xsi:type="dcterms:W3CDTF">2024-07-09T18:00:18Z</dcterms:created>
  <dcterms:modified xsi:type="dcterms:W3CDTF">2025-01-31T23:05:03Z</dcterms:modified>
</cp:coreProperties>
</file>